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07" d="100"/>
          <a:sy n="107" d="100"/>
        </p:scale>
        <p:origin x="1280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62710-A50C-FDC8-21DC-599E80C571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0F708E-FE29-D339-07EC-078B08B56E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F1D71-0004-CE36-8CEE-EBEC06D00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79362-B16A-9DF7-1C5E-048B15D5E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FF2E37-6355-9D1D-6E64-44D9D72CC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584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86AEE6-6652-BF39-56C3-E41A08FDA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C480DB-A9FB-E0B5-837E-9992A71175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AF391-8BB1-A6F5-9AFF-A2E2F64DC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2CECC7-35B0-6293-911E-B299C6A22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5FEB9-3A44-964B-CD56-04B667FDD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084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FA8D9C-5BDB-672E-C4BB-DC929728F5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0DD4FF-7643-6812-C1DF-BAF52B4293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88324-B2B1-B633-1D4F-D7F2A8B37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9125F0-C536-7CA6-0532-100F39686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DB32F5-F401-106C-81E9-DDF653BF3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848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1AD90-8185-CE2C-CB05-3B76171CC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61F130-AE03-DC7C-8855-0CF03432DD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F61B34-60F7-D438-EFB3-D4A5C7F5B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18B0D-BB49-B1CC-E5B0-B0C83B34A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CEF80-D7E9-7C2B-78B1-93133CC52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40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4ACFF-3DB9-0E37-F571-19B1774D8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EB2ED0-BEB3-0DB7-93CB-8BE1B63EC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C6A512-B548-7183-2005-AA0F6E03E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42DF55-CA3D-40CB-324E-A189952C3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03054-7128-86AE-A5E7-6BBCEE240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242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291BF6-4432-1B0E-5081-41EEB2D36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A0DE84-4C61-7C11-CB80-B18CB8F94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AEBC40-1981-7FBA-B4A6-9EB397D05D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91D527-65D0-2A9E-0A8D-34D994E58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83740-A38D-7560-BB80-E93CA7E66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B68DA5-2E4F-41F9-8112-E33A8A2DC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429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EDE6A-9948-A3CC-83CB-E90E2F6784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463A61-C396-09A9-6675-52BF3C1B8D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15F2CB-1DB1-2C05-22E3-D6880C2D5B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16ABDC-099A-0F7D-B91A-3F49FE284A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C0B04E-3232-925A-C437-9C8FD1F6D9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4CA044-3C2F-75F8-DDED-EB077994D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3C157C-3E4E-5F9B-B274-44AB3B4BD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B9D1BF-65CA-659E-FE97-4AB0F6055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731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B5654-C060-503A-6C9F-F3A6180EE7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1696EA-5DF4-5921-BB01-147D47098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50D6B4-9A68-2976-387C-16AFDE8E0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C57189-75B9-3C4C-924A-62F5E5668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22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A80A78-D0F9-C048-DD34-BC2192185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B15BAF-7CBC-5F15-B4A6-453ECFAE3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6E9269-23B3-0F5F-3799-BEB5D58C1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26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0B127-6CD8-075B-F225-B431EEFE5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FADAC2-8E26-587D-A436-C21DEC5A37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FF25A4-C3ED-BF65-E165-70161FF119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060BF-1A79-9AE7-29A2-7CC6BCDB8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30DBB1-24E5-CA46-7765-83F2D2A54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F73F99-F825-43D5-EC1C-F1951867E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3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D47D7-B303-261C-BCDD-50ADAA95B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64A6CA-629C-422C-B8AA-17D478183B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9E2F00-2AEF-72C7-9EFD-1BB5494723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F95408-685F-BE2E-4B28-0DEFAF3A8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38943-3C93-9345-3379-32309ED78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280093-9E94-D7E9-57A8-BD411B339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550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8C0B71-20E2-8119-EE3C-7636A28B8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176006-E2B8-67FE-BBAE-A6D1C5D0DE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8F333-FCEB-AF3C-4931-3E52B8A185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ACC615-C86E-EE4B-9E0E-AB0C2D541586}" type="datetimeFigureOut">
              <a:rPr lang="en-US" smtClean="0"/>
              <a:t>8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7333D-AC5E-7AFA-C0EA-44CB7672A5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43A741-392E-2654-E5C5-9E91D334D5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BF7468-B405-8C40-9C34-5F43088B73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38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07CEC-0FEA-2EA3-1C87-49FA5D0D275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nti-GBM Case Imag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A3CEBD-7AB7-AB64-35AA-4C7E4CC2CC6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726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41">
            <a:extLst>
              <a:ext uri="{FF2B5EF4-FFF2-40B4-BE49-F238E27FC236}">
                <a16:creationId xmlns:a16="http://schemas.microsoft.com/office/drawing/2014/main" id="{01D0AF59-99C3-4251-AB9A-C966C6AD440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855405F-37A2-4869-9154-F8BE3BECE6C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7012" y="480060"/>
            <a:ext cx="11237976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D9584-EBC7-A74A-31E5-6FB7A0798A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29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422D4-48CF-2A29-BF6F-12C26E9F2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D879C3C-94DA-14A6-C217-A168D1C621B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6020817"/>
              </p:ext>
            </p:extLst>
          </p:nvPr>
        </p:nvGraphicFramePr>
        <p:xfrm>
          <a:off x="5030118" y="381719"/>
          <a:ext cx="3294075" cy="60686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98025">
                  <a:extLst>
                    <a:ext uri="{9D8B030D-6E8A-4147-A177-3AD203B41FA5}">
                      <a16:colId xmlns:a16="http://schemas.microsoft.com/office/drawing/2014/main" val="661493767"/>
                    </a:ext>
                  </a:extLst>
                </a:gridCol>
                <a:gridCol w="1098025">
                  <a:extLst>
                    <a:ext uri="{9D8B030D-6E8A-4147-A177-3AD203B41FA5}">
                      <a16:colId xmlns:a16="http://schemas.microsoft.com/office/drawing/2014/main" val="2455140646"/>
                    </a:ext>
                  </a:extLst>
                </a:gridCol>
                <a:gridCol w="1098025">
                  <a:extLst>
                    <a:ext uri="{9D8B030D-6E8A-4147-A177-3AD203B41FA5}">
                      <a16:colId xmlns:a16="http://schemas.microsoft.com/office/drawing/2014/main" val="715055013"/>
                    </a:ext>
                  </a:extLst>
                </a:gridCol>
              </a:tblGrid>
              <a:tr h="38628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Range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1472368216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ium (mmol/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-14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380721057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tassium (mmol/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-5.1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1719373021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ide (mmol/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-110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4138632067"/>
                  </a:ext>
                </a:extLst>
              </a:tr>
              <a:tr h="40950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carbonate (mmol/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-32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138664426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on Gap (mmol/L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2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2961408935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 (mg/dL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-1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3694568078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N (mg/dL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-2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216993505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eatinine (mg/d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-1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1089678468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 (mL/min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6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1607128667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bumin (g/d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340" marR="47340" marT="47340" marB="4734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-4.7</a:t>
                      </a:r>
                    </a:p>
                  </a:txBody>
                  <a:tcPr marL="47340" marR="47340" marT="47340" marB="47340" anchor="ctr"/>
                </a:tc>
                <a:extLst>
                  <a:ext uri="{0D108BD9-81ED-4DB2-BD59-A6C34878D82A}">
                    <a16:rowId xmlns:a16="http://schemas.microsoft.com/office/drawing/2014/main" val="668920493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 (mm/</a:t>
                      </a: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2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4007747640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alcitonin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0.2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1506644676"/>
                  </a:ext>
                </a:extLst>
              </a:tr>
              <a:tr h="3862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 (g/d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-15.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278030960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BF64251-2628-2F40-B181-950BA6B4C5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7221776"/>
              </p:ext>
            </p:extLst>
          </p:nvPr>
        </p:nvGraphicFramePr>
        <p:xfrm>
          <a:off x="1896198" y="2013560"/>
          <a:ext cx="2766060" cy="427233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78560">
                  <a:extLst>
                    <a:ext uri="{9D8B030D-6E8A-4147-A177-3AD203B41FA5}">
                      <a16:colId xmlns:a16="http://schemas.microsoft.com/office/drawing/2014/main" val="2859099415"/>
                    </a:ext>
                  </a:extLst>
                </a:gridCol>
                <a:gridCol w="793750">
                  <a:extLst>
                    <a:ext uri="{9D8B030D-6E8A-4147-A177-3AD203B41FA5}">
                      <a16:colId xmlns:a16="http://schemas.microsoft.com/office/drawing/2014/main" val="1944573563"/>
                    </a:ext>
                  </a:extLst>
                </a:gridCol>
                <a:gridCol w="793750">
                  <a:extLst>
                    <a:ext uri="{9D8B030D-6E8A-4147-A177-3AD203B41FA5}">
                      <a16:colId xmlns:a16="http://schemas.microsoft.com/office/drawing/2014/main" val="3533895528"/>
                    </a:ext>
                  </a:extLst>
                </a:gridCol>
              </a:tblGrid>
              <a:tr h="53073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lete Blood Count; ESR; Procalcitonin</a:t>
                      </a: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Range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646272993"/>
                  </a:ext>
                </a:extLst>
              </a:tr>
              <a:tr h="36957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C (K/u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-11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55677431"/>
                  </a:ext>
                </a:extLst>
              </a:tr>
              <a:tr h="3894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C (M/u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-5.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46297941"/>
                  </a:ext>
                </a:extLst>
              </a:tr>
              <a:tr h="53073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 (g/dL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-15.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140376207"/>
                  </a:ext>
                </a:extLst>
              </a:tr>
              <a:tr h="3206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atocrit (%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-47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810380524"/>
                  </a:ext>
                </a:extLst>
              </a:tr>
              <a:tr h="36957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V (fL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-1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205409153"/>
                  </a:ext>
                </a:extLst>
              </a:tr>
              <a:tr h="320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H (pg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-33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313961932"/>
                  </a:ext>
                </a:extLst>
              </a:tr>
              <a:tr h="320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HC (g/dL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-36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949756379"/>
                  </a:ext>
                </a:extLst>
              </a:tr>
              <a:tr h="320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DW (%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16.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427891420"/>
                  </a:ext>
                </a:extLst>
              </a:tr>
              <a:tr h="320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 (mm/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2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756324305"/>
                  </a:ext>
                </a:extLst>
              </a:tr>
              <a:tr h="3204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alcitonin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buNone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0.24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18603295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301315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F81F4-22CA-AE1D-8B27-031E16878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graphicFrame>
        <p:nvGraphicFramePr>
          <p:cNvPr id="16" name="Content Placeholder 15">
            <a:extLst>
              <a:ext uri="{FF2B5EF4-FFF2-40B4-BE49-F238E27FC236}">
                <a16:creationId xmlns:a16="http://schemas.microsoft.com/office/drawing/2014/main" id="{3BBD829C-9311-47BD-DCD9-3542E85DB48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87319979"/>
              </p:ext>
            </p:extLst>
          </p:nvPr>
        </p:nvGraphicFramePr>
        <p:xfrm>
          <a:off x="838200" y="1825625"/>
          <a:ext cx="10515597" cy="296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05199">
                  <a:extLst>
                    <a:ext uri="{9D8B030D-6E8A-4147-A177-3AD203B41FA5}">
                      <a16:colId xmlns:a16="http://schemas.microsoft.com/office/drawing/2014/main" val="2286114213"/>
                    </a:ext>
                  </a:extLst>
                </a:gridCol>
                <a:gridCol w="3505199">
                  <a:extLst>
                    <a:ext uri="{9D8B030D-6E8A-4147-A177-3AD203B41FA5}">
                      <a16:colId xmlns:a16="http://schemas.microsoft.com/office/drawing/2014/main" val="14147048"/>
                    </a:ext>
                  </a:extLst>
                </a:gridCol>
                <a:gridCol w="3505199">
                  <a:extLst>
                    <a:ext uri="{9D8B030D-6E8A-4147-A177-3AD203B41FA5}">
                      <a16:colId xmlns:a16="http://schemas.microsoft.com/office/drawing/2014/main" val="199266997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/Procedur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pretation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02838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opped to 6.6 g/dL (baseline ~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vere anemia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865540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elet Cou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opped to a low of 50,000/</a:t>
                      </a:r>
                      <a:r>
                        <a:rPr lang="el-GR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 thrombocytopenia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727957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ptoglob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31 mg/d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ggestive of hemolysi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129718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 Coombs (DAT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lysis is not immune-relate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36936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T Pane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etermin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T not confirme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08777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Endoscopy &amp; Colonosco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ld antral erythema; no bleedin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GI source of bleeding identifie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354508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 Abdomen/Pelvi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for retroperitoneal blee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procedural complication foun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65312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97814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4F7A1A3C-F8F5-E163-2E4F-472CEAF599F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44462253"/>
              </p:ext>
            </p:extLst>
          </p:nvPr>
        </p:nvGraphicFramePr>
        <p:xfrm>
          <a:off x="1378015" y="260927"/>
          <a:ext cx="9120660" cy="63361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92396">
                  <a:extLst>
                    <a:ext uri="{9D8B030D-6E8A-4147-A177-3AD203B41FA5}">
                      <a16:colId xmlns:a16="http://schemas.microsoft.com/office/drawing/2014/main" val="3731521521"/>
                    </a:ext>
                  </a:extLst>
                </a:gridCol>
                <a:gridCol w="880788">
                  <a:extLst>
                    <a:ext uri="{9D8B030D-6E8A-4147-A177-3AD203B41FA5}">
                      <a16:colId xmlns:a16="http://schemas.microsoft.com/office/drawing/2014/main" val="2510889036"/>
                    </a:ext>
                  </a:extLst>
                </a:gridCol>
                <a:gridCol w="2787016">
                  <a:extLst>
                    <a:ext uri="{9D8B030D-6E8A-4147-A177-3AD203B41FA5}">
                      <a16:colId xmlns:a16="http://schemas.microsoft.com/office/drawing/2014/main" val="541510056"/>
                    </a:ext>
                  </a:extLst>
                </a:gridCol>
                <a:gridCol w="1012252">
                  <a:extLst>
                    <a:ext uri="{9D8B030D-6E8A-4147-A177-3AD203B41FA5}">
                      <a16:colId xmlns:a16="http://schemas.microsoft.com/office/drawing/2014/main" val="2879506357"/>
                    </a:ext>
                  </a:extLst>
                </a:gridCol>
                <a:gridCol w="2031097">
                  <a:extLst>
                    <a:ext uri="{9D8B030D-6E8A-4147-A177-3AD203B41FA5}">
                      <a16:colId xmlns:a16="http://schemas.microsoft.com/office/drawing/2014/main" val="868187611"/>
                    </a:ext>
                  </a:extLst>
                </a:gridCol>
                <a:gridCol w="1117111">
                  <a:extLst>
                    <a:ext uri="{9D8B030D-6E8A-4147-A177-3AD203B41FA5}">
                      <a16:colId xmlns:a16="http://schemas.microsoft.com/office/drawing/2014/main" val="3500210395"/>
                    </a:ext>
                  </a:extLst>
                </a:gridCol>
              </a:tblGrid>
              <a:tr h="492022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ation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mographic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set Relative to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lmonary Involvemen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989803755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bastian et al. (2021) – Case 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4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mild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cyclophosphamide, dialysi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tial Renal Recovery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910603508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bastian et al. (2021) – Case 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8 weeks post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mild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cyclophosphamide, dialysi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D, not dialysis 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270277250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bastian et al. (2021) – Case 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M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6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mild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cyclophosphamide, dialysi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423803931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bastian et al. (2021) – Case 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F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6 weeks post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mild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cyclophosphamide, dialysi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483030545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nkler et al. (2021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COVID-19 infection. Anti-GBM relapse occurred during active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pulmonary hemorrhag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1247304053"/>
                  </a:ext>
                </a:extLst>
              </a:tr>
              <a:tr h="186304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bu et al. (2022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8 weeks post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nal recovery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331411728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enoy et al. (2022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urrent with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 – COVID pneumonia only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 deferred; no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1008475925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 et al. (2025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4 weeks post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proved (no dialysis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1052498729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 week post COVID-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</a:p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502719503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5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D V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2105926321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 week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2919957957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7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e (in ESKD)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lysis-dependent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4272321041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3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D V, not on dialysi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243547864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2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D IV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3541007879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8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nal recover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2247226760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ndecki et al. (2020) – Case 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F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2 weeks post COVID-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roids, plasmapheresis, rituximab, cyclophosphamid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nal recover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76128000"/>
                  </a:ext>
                </a:extLst>
              </a:tr>
              <a:tr h="336548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verages</a:t>
                      </a: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 years old</a:t>
                      </a: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-4 weeks average onset</a:t>
                      </a: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% with pulmonary involvement</a:t>
                      </a:r>
                    </a:p>
                    <a:p>
                      <a:pPr marL="0" marR="0" algn="ctr">
                        <a:buNone/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8% on Immunosuppressive Therapy</a:t>
                      </a:r>
                    </a:p>
                  </a:txBody>
                  <a:tcPr marL="24717" marR="2471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% achieved renal recovery</a:t>
                      </a:r>
                    </a:p>
                  </a:txBody>
                  <a:tcPr marL="24717" marR="24717" marT="0" marB="0" anchor="ctr"/>
                </a:tc>
                <a:extLst>
                  <a:ext uri="{0D108BD9-81ED-4DB2-BD59-A6C34878D82A}">
                    <a16:rowId xmlns:a16="http://schemas.microsoft.com/office/drawing/2014/main" val="42392920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67879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205B48-2D29-2053-8481-DE5B40AFB3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FBFCAA-B64F-5C3E-C042-8F19BEE8FE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664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</TotalTime>
  <Words>716</Words>
  <Application>Microsoft Macintosh PowerPoint</Application>
  <PresentationFormat>Widescreen</PresentationFormat>
  <Paragraphs>20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Anti-GBM Case Imag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se, Justin</dc:creator>
  <cp:lastModifiedBy>Tse, Justin</cp:lastModifiedBy>
  <cp:revision>7</cp:revision>
  <dcterms:created xsi:type="dcterms:W3CDTF">2025-06-07T10:02:25Z</dcterms:created>
  <dcterms:modified xsi:type="dcterms:W3CDTF">2025-08-17T21:55:44Z</dcterms:modified>
</cp:coreProperties>
</file>